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4" r:id="rId2"/>
  </p:sldIdLst>
  <p:sldSz cx="9144000" cy="6858000" type="screen4x3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4" autoAdjust="0"/>
    <p:restoredTop sz="94580" autoAdjust="0"/>
  </p:normalViewPr>
  <p:slideViewPr>
    <p:cSldViewPr>
      <p:cViewPr>
        <p:scale>
          <a:sx n="70" d="100"/>
          <a:sy n="70" d="100"/>
        </p:scale>
        <p:origin x="-1422" y="-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B8C867A7-A559-4C3A-B403-2C76D329D475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6"/>
            <a:ext cx="5560060" cy="41562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9AC42040-FD27-45EF-AAD0-614F035C0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417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44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464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798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239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949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7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372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37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509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760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00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BDB26-DBEA-4E23-97D3-D5DD4FA2451E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FF7B8-970F-4EEB-BB73-1E80FA78D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715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335871" y="460177"/>
            <a:ext cx="8472259" cy="5937647"/>
            <a:chOff x="335871" y="460177"/>
            <a:chExt cx="8472259" cy="5937647"/>
          </a:xfrm>
        </p:grpSpPr>
        <p:grpSp>
          <p:nvGrpSpPr>
            <p:cNvPr id="21" name="Group 20"/>
            <p:cNvGrpSpPr/>
            <p:nvPr/>
          </p:nvGrpSpPr>
          <p:grpSpPr>
            <a:xfrm>
              <a:off x="335871" y="1227178"/>
              <a:ext cx="8472259" cy="5170646"/>
              <a:chOff x="0" y="1071801"/>
              <a:chExt cx="8472259" cy="5170646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0" y="1071801"/>
                <a:ext cx="7315200" cy="5170646"/>
              </a:xfrm>
              <a:prstGeom prst="rect">
                <a:avLst/>
              </a:prstGeom>
              <a:ln>
                <a:noFill/>
              </a:ln>
            </p:spPr>
            <p:txBody>
              <a:bodyPr>
                <a:spAutoFit/>
              </a:bodyPr>
              <a:lstStyle/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emale athymic nude mice (</a:t>
                </a:r>
                <a:r>
                  <a:rPr lang="en-US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rl:NU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Cr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-</a:t>
                </a:r>
                <a:r>
                  <a:rPr lang="en-US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oxn1</a:t>
                </a:r>
                <a:r>
                  <a:rPr lang="en-US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u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ge: 7 week</a:t>
                </a:r>
              </a:p>
              <a:p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lank injection of 1 million ACI-98 cells suspended in </a:t>
                </a: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 1:1 mixture of PBS/</a:t>
                </a:r>
                <a:r>
                  <a:rPr lang="en-US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atrigel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mice per group: Water vs 2% w/v DFMO</a:t>
                </a:r>
              </a:p>
              <a:p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Be monitored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very 2 days until tumor mean volume: 150 – 200 mm</a:t>
                </a:r>
                <a:r>
                  <a:rPr lang="en-US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rt to record</a:t>
                </a:r>
              </a:p>
              <a:p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crificed when significant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regression is observed or </a:t>
                </a:r>
                <a:endParaRPr lang="en-US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en the mean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volume achieves 2,000 mm</a:t>
                </a:r>
                <a:r>
                  <a:rPr lang="en-US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marL="182880" indent="-182880">
                  <a:buFont typeface="Arial" panose="020B0604020202020204" pitchFamily="34" charset="0"/>
                  <a:buChar char="•"/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hole blood collection by cardiac puncture</a:t>
                </a:r>
              </a:p>
              <a:p>
                <a:pPr marL="182880" indent="-182880">
                  <a:buFont typeface="Arial" panose="020B0604020202020204" pitchFamily="34" charset="0"/>
                  <a:buChar char="•"/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nap frozen of  one part of dissected tumors</a:t>
                </a:r>
              </a:p>
              <a:p>
                <a:pPr marL="182880" indent="-182880">
                  <a:buFont typeface="Arial" panose="020B0604020202020204" pitchFamily="34" charset="0"/>
                  <a:buChar char="•"/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x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with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% PFA of other part for histology </a:t>
                </a:r>
              </a:p>
            </p:txBody>
          </p:sp>
          <p:grpSp>
            <p:nvGrpSpPr>
              <p:cNvPr id="20" name="Group 19"/>
              <p:cNvGrpSpPr/>
              <p:nvPr/>
            </p:nvGrpSpPr>
            <p:grpSpPr>
              <a:xfrm>
                <a:off x="7190779" y="1071801"/>
                <a:ext cx="1281480" cy="5170646"/>
                <a:chOff x="7190779" y="1071801"/>
                <a:chExt cx="1281480" cy="5170646"/>
              </a:xfrm>
            </p:grpSpPr>
            <p:sp>
              <p:nvSpPr>
                <p:cNvPr id="3" name="TextBox 2"/>
                <p:cNvSpPr txBox="1"/>
                <p:nvPr/>
              </p:nvSpPr>
              <p:spPr>
                <a:xfrm>
                  <a:off x="7543800" y="2282407"/>
                  <a:ext cx="80021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y 0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7543800" y="3657124"/>
                  <a:ext cx="9284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y 10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7543800" y="4850830"/>
                  <a:ext cx="9284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y 19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7315200" y="1071801"/>
                  <a:ext cx="0" cy="517064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 rot="5400000">
                  <a:off x="7327939" y="965499"/>
                  <a:ext cx="0" cy="27432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 rot="5400000">
                  <a:off x="7327939" y="6088827"/>
                  <a:ext cx="0" cy="27432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 rot="5400000">
                  <a:off x="7406640" y="2375633"/>
                  <a:ext cx="0" cy="18288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 rot="5400000">
                  <a:off x="7406640" y="3750350"/>
                  <a:ext cx="0" cy="18288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 rot="5400000">
                  <a:off x="7406640" y="4944056"/>
                  <a:ext cx="0" cy="18288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" name="Rectangle 3"/>
            <p:cNvSpPr/>
            <p:nvPr/>
          </p:nvSpPr>
          <p:spPr>
            <a:xfrm>
              <a:off x="1534150" y="460177"/>
              <a:ext cx="6075702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ow chart of animal study design </a:t>
              </a:r>
            </a:p>
          </p:txBody>
        </p:sp>
        <p:sp>
          <p:nvSpPr>
            <p:cNvPr id="7" name="Down Arrow 6"/>
            <p:cNvSpPr/>
            <p:nvPr/>
          </p:nvSpPr>
          <p:spPr>
            <a:xfrm>
              <a:off x="731520" y="1923217"/>
              <a:ext cx="182880" cy="36576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Down Arrow 7"/>
            <p:cNvSpPr/>
            <p:nvPr/>
          </p:nvSpPr>
          <p:spPr>
            <a:xfrm>
              <a:off x="731520" y="3371017"/>
              <a:ext cx="182880" cy="36576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Down Arrow 8"/>
            <p:cNvSpPr/>
            <p:nvPr/>
          </p:nvSpPr>
          <p:spPr>
            <a:xfrm>
              <a:off x="731520" y="4437817"/>
              <a:ext cx="182880" cy="36576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785631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2</TotalTime>
  <Words>10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 Im Kim</dc:creator>
  <cp:lastModifiedBy>Hong Im Kim</cp:lastModifiedBy>
  <cp:revision>95</cp:revision>
  <cp:lastPrinted>2017-10-03T20:37:06Z</cp:lastPrinted>
  <dcterms:created xsi:type="dcterms:W3CDTF">2016-03-17T20:05:28Z</dcterms:created>
  <dcterms:modified xsi:type="dcterms:W3CDTF">2017-10-06T14:56:10Z</dcterms:modified>
</cp:coreProperties>
</file>